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471" r:id="rId2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100" autoAdjust="0"/>
    <p:restoredTop sz="94660"/>
  </p:normalViewPr>
  <p:slideViewPr>
    <p:cSldViewPr snapToGrid="0">
      <p:cViewPr varScale="1">
        <p:scale>
          <a:sx n="62" d="100"/>
          <a:sy n="62" d="100"/>
        </p:scale>
        <p:origin x="52" y="148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9B0618-1C25-4047-A976-386415E4D42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ACEEF58-2AA2-414F-8B11-7041C66C325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5A0A6B-2A86-4DE4-A043-C841491050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F42E64-9BC3-4F39-94FC-0AAEF9391CAE}" type="datetimeFigureOut">
              <a:rPr lang="nb-NO" smtClean="0"/>
              <a:t>26.03.2024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81197F-4B02-4650-B2B2-58E53C9A95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AC73AE-6315-43D0-9A0A-DEC558BD9A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678B3-7EA9-4D3D-B3C0-EA8257599F7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2858534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E7996D-4592-4C44-A22B-A5566ED55A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C6F6FE0-8ED2-421A-B227-83DAB866AA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9EDC63-7367-4E70-A679-5E0F9CEFD4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F42E64-9BC3-4F39-94FC-0AAEF9391CAE}" type="datetimeFigureOut">
              <a:rPr lang="nb-NO" smtClean="0"/>
              <a:t>26.03.2024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D58700-0D11-4FB9-A773-E311AD9289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7A15BD-F5BC-4B9C-9926-B8705AAFA1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678B3-7EA9-4D3D-B3C0-EA8257599F7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2525546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34F8CE5-C44D-4784-8EAB-7434B25BC8B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F536B2E-C241-4828-8360-526CC85C2F4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04A1A7-787D-4A06-B8D2-88DA45808C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F42E64-9BC3-4F39-94FC-0AAEF9391CAE}" type="datetimeFigureOut">
              <a:rPr lang="nb-NO" smtClean="0"/>
              <a:t>26.03.2024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0BD1EB-D819-4F58-98C6-4F69AB3456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57A447-9FB7-41F4-9634-AF72E1EB29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678B3-7EA9-4D3D-B3C0-EA8257599F7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8993468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982DDE-335A-4D38-B837-E24C4F1728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1736E3-77D9-4E52-858E-0C12C3D6EF4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0DBD99-2054-4E00-BC07-26C6474AC3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F42E64-9BC3-4F39-94FC-0AAEF9391CAE}" type="datetimeFigureOut">
              <a:rPr lang="nb-NO" smtClean="0"/>
              <a:t>26.03.2024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77B2E6-180A-4E95-AF26-17EC577ED7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A888E3-22DB-4B52-9D7C-83EFD7DDC0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678B3-7EA9-4D3D-B3C0-EA8257599F7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1631430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1E9B03-3934-4512-96F2-EA6C5382BB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A3BDE09-CDF0-4D2E-A645-B0BD8A5B53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89B286-8BE6-4709-B95B-47F0F3D188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F42E64-9BC3-4F39-94FC-0AAEF9391CAE}" type="datetimeFigureOut">
              <a:rPr lang="nb-NO" smtClean="0"/>
              <a:t>26.03.2024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24F118-D745-42F9-B4FC-E84D328883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420409-2B4A-45C5-80FA-76C9D89610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678B3-7EA9-4D3D-B3C0-EA8257599F7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426981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C58B20-1C48-4150-A40E-2E39BC808B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B251F57-E311-4E03-9C14-C4ED4E41ABE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8626159-3F0D-4415-A5E5-51D00CE679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BD35FD-3B06-4462-82C2-AF9BFA5267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F42E64-9BC3-4F39-94FC-0AAEF9391CAE}" type="datetimeFigureOut">
              <a:rPr lang="nb-NO" smtClean="0"/>
              <a:t>26.03.2024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6FD820-DA28-4D26-AEAE-0A52FAE802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FF76691-179A-403F-9FA3-461337EAC0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678B3-7EA9-4D3D-B3C0-EA8257599F7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3787170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6E5485-D574-4233-93CD-F6349D5080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DC3F689-664E-40D1-828F-F25FC22A46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0E8155-CDCE-4DDF-80B3-FF1B712E9F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91DE5BF-954A-417A-B762-F33E113367C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3FA6F04-A0D6-4DC9-BE23-DCABB1D7421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6086DE7-733F-4638-A6DA-3BF5297AE0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F42E64-9BC3-4F39-94FC-0AAEF9391CAE}" type="datetimeFigureOut">
              <a:rPr lang="nb-NO" smtClean="0"/>
              <a:t>26.03.2024</a:t>
            </a:fld>
            <a:endParaRPr lang="nb-NO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79CCEA7-FD82-4035-A86A-8690201377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7557540-C98B-4B0A-9284-F3643277CC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678B3-7EA9-4D3D-B3C0-EA8257599F7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295760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FAEA86-A5D3-46C8-9495-08FC20DF88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F845BDC-952A-4A1D-A654-78A11E692C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F42E64-9BC3-4F39-94FC-0AAEF9391CAE}" type="datetimeFigureOut">
              <a:rPr lang="nb-NO" smtClean="0"/>
              <a:t>26.03.2024</a:t>
            </a:fld>
            <a:endParaRPr lang="nb-NO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DA69BED-AE9E-4F1B-A6A3-543883E436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9122667-31C4-4BD1-A1D4-667AC00569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678B3-7EA9-4D3D-B3C0-EA8257599F7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3890424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24F36FF-1E6E-47A5-94AD-11F1342E54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F42E64-9BC3-4F39-94FC-0AAEF9391CAE}" type="datetimeFigureOut">
              <a:rPr lang="nb-NO" smtClean="0"/>
              <a:t>26.03.2024</a:t>
            </a:fld>
            <a:endParaRPr lang="nb-NO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B7CECD4-28AD-48D1-A292-3B3C2A7156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A036A21-D03A-4DBC-A74F-BB8E2B8948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678B3-7EA9-4D3D-B3C0-EA8257599F7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9185329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3ECF02-C4FE-4FF2-8C82-C0AD750CFE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CB278ED-1F26-4D59-91E7-343F06D01F9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A9BAD4A-2748-4B4C-ADBB-FC83A3BBE5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DBDEF1C-8C94-4273-94E6-3879535DA8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F42E64-9BC3-4F39-94FC-0AAEF9391CAE}" type="datetimeFigureOut">
              <a:rPr lang="nb-NO" smtClean="0"/>
              <a:t>26.03.2024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C7BFE3A-2114-44C0-938E-7BE05C9F4B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EE23F6-2BB8-4B55-AD62-C3D1093BE1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678B3-7EA9-4D3D-B3C0-EA8257599F7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3071637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448DE0-F746-4FDA-B809-BE43210B97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0310CE0-0E62-4DF8-AFED-16122606C95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7FD59A4-0E65-4B55-8E9D-1F54829CF2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4ABC73-6B5A-4D8C-9845-62C2A30A84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F42E64-9BC3-4F39-94FC-0AAEF9391CAE}" type="datetimeFigureOut">
              <a:rPr lang="nb-NO" smtClean="0"/>
              <a:t>26.03.2024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CCD268-FC56-49FE-B36B-50BD83483E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A57255-5961-4435-813F-A311170F05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678B3-7EA9-4D3D-B3C0-EA8257599F7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8290538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1EB0818-076D-4AC6-BE95-23E57A8499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F585BBC-C140-4C09-B21F-20CA35F2C1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402A4E-BCF7-45F2-A097-9D005F6BE67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F42E64-9BC3-4F39-94FC-0AAEF9391CAE}" type="datetimeFigureOut">
              <a:rPr lang="nb-NO" smtClean="0"/>
              <a:t>26.03.2024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08E4D0-E88A-47D1-866B-5B3DA6D98BD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950AA3-D151-4BDA-B861-5BE4530E2BA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D678B3-7EA9-4D3D-B3C0-EA8257599F7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3347683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9F5EF7-6012-FB8D-3271-BFB0B858A2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28588" y="111235"/>
            <a:ext cx="11934824" cy="1325563"/>
          </a:xfrm>
        </p:spPr>
        <p:txBody>
          <a:bodyPr>
            <a:normAutofit/>
          </a:bodyPr>
          <a:lstStyle/>
          <a:p>
            <a:r>
              <a:rPr lang="en-US" sz="28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l Figure 1.</a:t>
            </a:r>
            <a:r>
              <a:rPr lang="en-US" sz="2800" b="1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LC-MS/MS chromatograms of 17</a:t>
            </a:r>
            <a:r>
              <a:rPr lang="el-GR" sz="28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α</a:t>
            </a:r>
            <a:r>
              <a:rPr lang="en-US" sz="28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-hydroxyprogesterone and Testosterone, and their corresponding epimers. </a:t>
            </a:r>
            <a:endParaRPr lang="nb-NO" sz="2800" b="1" dirty="0"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BF15C71-21E9-765E-46D8-90D2FAF05C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8249" y="3618913"/>
            <a:ext cx="3721016" cy="194031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AB895D0-81EA-5472-1415-077A8A82DD1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60468" y="3570730"/>
            <a:ext cx="3875479" cy="2034627"/>
          </a:xfrm>
          <a:prstGeom prst="rect">
            <a:avLst/>
          </a:prstGeom>
          <a:noFill/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E7795943-D68F-0F52-D779-7EF449ABF2C2}"/>
              </a:ext>
            </a:extLst>
          </p:cNvPr>
          <p:cNvSpPr txBox="1"/>
          <p:nvPr/>
        </p:nvSpPr>
        <p:spPr>
          <a:xfrm>
            <a:off x="128588" y="5559223"/>
            <a:ext cx="1193482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Legend: 1). 17</a:t>
            </a:r>
            <a:r>
              <a:rPr lang="el-GR" sz="18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α</a:t>
            </a:r>
            <a:r>
              <a:rPr lang="en-US" sz="18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-hydroxyprogesterone ; 2). 17β-hydroxyprogesterone; 3). Testosterone; 4). Epi-testosterone. The LC-MS/MS experiments were carried out similarly as described in Section 1.4, with a slightly different chromatography condition. In which, the chromatography separation was performed by use of the two analytical columns (without Guard-column), and the mobile phase flow was 0.3 µl/min.</a:t>
            </a:r>
            <a:endParaRPr lang="nb-NO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E79B41F6-246D-F8E1-24BD-BFE8F8C4972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93396" y="1481284"/>
            <a:ext cx="4032504" cy="2073625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3F2D4499-5074-3336-707C-FB4F40AA154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318165" y="1414824"/>
            <a:ext cx="4032504" cy="21037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131642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2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Supplemental Figure 1. LC-MS/MS chromatograms of 17α-hydroxyprogesterone and Testosterone, and their corresponding epimers.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1 and E2</dc:title>
  <dc:creator>Feng Wang</dc:creator>
  <cp:lastModifiedBy>Feng Wang</cp:lastModifiedBy>
  <cp:revision>223</cp:revision>
  <dcterms:created xsi:type="dcterms:W3CDTF">2022-04-19T14:11:06Z</dcterms:created>
  <dcterms:modified xsi:type="dcterms:W3CDTF">2024-03-26T11:49:25Z</dcterms:modified>
</cp:coreProperties>
</file>